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5940425" cy="82804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3" d="100"/>
          <a:sy n="63" d="100"/>
        </p:scale>
        <p:origin x="-2292" y="-132"/>
      </p:cViewPr>
      <p:guideLst>
        <p:guide orient="horz" pos="2608"/>
        <p:guide pos="18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9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7336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8405" y="440856"/>
            <a:ext cx="5123617" cy="16004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8405" y="2204276"/>
            <a:ext cx="5123617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8405" y="7674709"/>
            <a:ext cx="1336596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18/9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7767" y="7674709"/>
            <a:ext cx="2004894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95425" y="7674709"/>
            <a:ext cx="1336596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3366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611999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0" indent="-153000" algn="l" defTabSz="611999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8999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4998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0996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6996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2995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994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4993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0992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5999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1999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7997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3996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29995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5995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1994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7992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761945" y="-147879"/>
            <a:ext cx="3938817" cy="3817646"/>
            <a:chOff x="1061806" y="2559032"/>
            <a:chExt cx="1722360" cy="1643351"/>
          </a:xfrm>
        </p:grpSpPr>
        <p:sp>
          <p:nvSpPr>
            <p:cNvPr id="5" name="文本框 161"/>
            <p:cNvSpPr txBox="1"/>
            <p:nvPr/>
          </p:nvSpPr>
          <p:spPr>
            <a:xfrm>
              <a:off x="1061806" y="2661261"/>
              <a:ext cx="286744" cy="203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400" dirty="0">
                  <a:latin typeface="Arial" panose="020B0604020202020204" pitchFamily="34" charset="0"/>
                  <a:ea typeface="Arial Unicode MS" panose="020B0604020202020204" charset="-122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56026" y="3093880"/>
              <a:ext cx="1428140" cy="1015566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1873932" y="2778398"/>
              <a:ext cx="500517" cy="172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7402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630428" y="4043400"/>
              <a:ext cx="355526" cy="1589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2179804" y="4043400"/>
              <a:ext cx="523784" cy="1589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FAM134B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 rot="10800000">
              <a:off x="1219256" y="2559032"/>
              <a:ext cx="188418" cy="153144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</a:t>
              </a:r>
              <a:r>
                <a: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level of Snail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10"/>
            <p:cNvCxnSpPr/>
            <p:nvPr/>
          </p:nvCxnSpPr>
          <p:spPr>
            <a:xfrm>
              <a:off x="1800107" y="3144430"/>
              <a:ext cx="63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1804358" y="3144430"/>
              <a:ext cx="0" cy="80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2430983" y="3144430"/>
              <a:ext cx="0" cy="8662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13"/>
            <p:cNvSpPr txBox="1"/>
            <p:nvPr/>
          </p:nvSpPr>
          <p:spPr>
            <a:xfrm>
              <a:off x="1881610" y="2986774"/>
              <a:ext cx="501326" cy="172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p &lt; </a:t>
              </a:r>
              <a:r>
                <a:rPr lang="en-US" altLang="zh-CN" sz="2000" dirty="0" smtClean="0"/>
                <a:t>0.001</a:t>
              </a:r>
              <a:endParaRPr lang="zh-CN" altLang="en-US" sz="2000" dirty="0"/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749305" y="3554293"/>
            <a:ext cx="4098141" cy="3641067"/>
            <a:chOff x="771932" y="3476611"/>
            <a:chExt cx="4221896" cy="3561488"/>
          </a:xfrm>
        </p:grpSpPr>
        <p:grpSp>
          <p:nvGrpSpPr>
            <p:cNvPr id="16" name="组合 15"/>
            <p:cNvGrpSpPr/>
            <p:nvPr/>
          </p:nvGrpSpPr>
          <p:grpSpPr>
            <a:xfrm>
              <a:off x="771932" y="3476611"/>
              <a:ext cx="4221896" cy="3561488"/>
              <a:chOff x="3043384" y="2731690"/>
              <a:chExt cx="1725519" cy="1470195"/>
            </a:xfrm>
          </p:grpSpPr>
          <p:sp>
            <p:nvSpPr>
              <p:cNvPr id="17" name="文本框 161"/>
              <p:cNvSpPr txBox="1"/>
              <p:nvPr/>
            </p:nvSpPr>
            <p:spPr>
              <a:xfrm>
                <a:off x="3043384" y="2731690"/>
                <a:ext cx="286744" cy="1905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2400" dirty="0">
                    <a:latin typeface="Arial" panose="020B0604020202020204" pitchFamily="34" charset="0"/>
                    <a:ea typeface="Arial Unicode MS" panose="020B0604020202020204" charset="-122"/>
                    <a:cs typeface="Arial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18" name="组合 17"/>
              <p:cNvGrpSpPr/>
              <p:nvPr/>
            </p:nvGrpSpPr>
            <p:grpSpPr>
              <a:xfrm>
                <a:off x="3368942" y="2809087"/>
                <a:ext cx="1399961" cy="1392798"/>
                <a:chOff x="3368942" y="2809087"/>
                <a:chExt cx="1399961" cy="1392798"/>
              </a:xfrm>
            </p:grpSpPr>
            <p:pic>
              <p:nvPicPr>
                <p:cNvPr id="20" name="图片 19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68942" y="3166716"/>
                  <a:ext cx="1399961" cy="901520"/>
                </a:xfrm>
                <a:prstGeom prst="rect">
                  <a:avLst/>
                </a:prstGeom>
              </p:spPr>
            </p:pic>
            <p:sp>
              <p:nvSpPr>
                <p:cNvPr id="21" name="文本框 20"/>
                <p:cNvSpPr txBox="1"/>
                <p:nvPr/>
              </p:nvSpPr>
              <p:spPr>
                <a:xfrm>
                  <a:off x="3850518" y="2809087"/>
                  <a:ext cx="442284" cy="1615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LF</a:t>
                  </a:r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3513133" y="4052756"/>
                  <a:ext cx="353130" cy="1491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h</a:t>
                  </a:r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NC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文本框 22"/>
                <p:cNvSpPr txBox="1"/>
                <p:nvPr/>
              </p:nvSpPr>
              <p:spPr>
                <a:xfrm>
                  <a:off x="3921108" y="4052756"/>
                  <a:ext cx="380128" cy="1491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-F#1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本框 23"/>
                <p:cNvSpPr txBox="1"/>
                <p:nvPr/>
              </p:nvSpPr>
              <p:spPr>
                <a:xfrm>
                  <a:off x="4347546" y="4052756"/>
                  <a:ext cx="380128" cy="1491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-F#2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5" name="直接连接符 24"/>
                <p:cNvCxnSpPr/>
                <p:nvPr/>
              </p:nvCxnSpPr>
              <p:spPr>
                <a:xfrm>
                  <a:off x="3694501" y="3140794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接连接符 25"/>
                <p:cNvCxnSpPr/>
                <p:nvPr/>
              </p:nvCxnSpPr>
              <p:spPr>
                <a:xfrm>
                  <a:off x="3698727" y="3143969"/>
                  <a:ext cx="633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接连接符 26"/>
                <p:cNvCxnSpPr/>
                <p:nvPr/>
              </p:nvCxnSpPr>
              <p:spPr>
                <a:xfrm>
                  <a:off x="4332952" y="3147144"/>
                  <a:ext cx="0" cy="40098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接连接符 27"/>
                <p:cNvCxnSpPr/>
                <p:nvPr/>
              </p:nvCxnSpPr>
              <p:spPr>
                <a:xfrm>
                  <a:off x="4126212" y="3548129"/>
                  <a:ext cx="41983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连接符 28"/>
                <p:cNvCxnSpPr/>
                <p:nvPr/>
              </p:nvCxnSpPr>
              <p:spPr>
                <a:xfrm>
                  <a:off x="4126212" y="3548129"/>
                  <a:ext cx="0" cy="1569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接连接符 29"/>
                <p:cNvCxnSpPr/>
                <p:nvPr/>
              </p:nvCxnSpPr>
              <p:spPr>
                <a:xfrm>
                  <a:off x="4546042" y="3548129"/>
                  <a:ext cx="0" cy="7849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文本框 30"/>
                <p:cNvSpPr txBox="1"/>
                <p:nvPr/>
              </p:nvSpPr>
              <p:spPr>
                <a:xfrm>
                  <a:off x="3759605" y="2982412"/>
                  <a:ext cx="428049" cy="16155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2000" dirty="0"/>
                    <a:t>p &lt; </a:t>
                  </a:r>
                  <a:r>
                    <a:rPr lang="en-US" altLang="zh-CN" sz="2000" dirty="0" smtClean="0"/>
                    <a:t>0.01</a:t>
                  </a:r>
                  <a:endParaRPr lang="zh-CN" altLang="en-US" sz="2000" dirty="0"/>
                </a:p>
              </p:txBody>
            </p:sp>
          </p:grpSp>
        </p:grpSp>
        <p:sp>
          <p:nvSpPr>
            <p:cNvPr id="33" name="文本框 32"/>
            <p:cNvSpPr txBox="1"/>
            <p:nvPr/>
          </p:nvSpPr>
          <p:spPr>
            <a:xfrm rot="10800000">
              <a:off x="1125507" y="3695778"/>
              <a:ext cx="443899" cy="314927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</a:t>
              </a:r>
              <a:r>
                <a: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level of Snail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73097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wrap="square">
        <a:spAutoFit/>
      </a:bodyPr>
      <a:lstStyle>
        <a:defPPr algn="just">
          <a:defRPr sz="1100" dirty="0">
            <a:latin typeface="Arial" panose="020B0604020202020204" pitchFamily="34" charset="0"/>
            <a:cs typeface="Arial" panose="020B0604020202020204" pitchFamily="34" charset="0"/>
          </a:defRPr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57</TotalTime>
  <Words>25</Words>
  <Application>Microsoft Office PowerPoint</Application>
  <PresentationFormat>自定义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zzq</dc:creator>
  <dc:description/>
  <cp:lastModifiedBy>zzq</cp:lastModifiedBy>
  <cp:revision>383</cp:revision>
  <dcterms:created xsi:type="dcterms:W3CDTF">2015-05-05T08:02:00Z</dcterms:created>
  <dcterms:modified xsi:type="dcterms:W3CDTF">2018-09-09T13:17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690</vt:lpwstr>
  </property>
  <property fmtid="{D5CDD505-2E9C-101B-9397-08002B2CF9AE}" pid="3" name="Presentation">
    <vt:lpwstr>Figures</vt:lpwstr>
  </property>
  <property fmtid="{D5CDD505-2E9C-101B-9397-08002B2CF9AE}" pid="4" name="SlideDescription">
    <vt:lpwstr/>
  </property>
</Properties>
</file>